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04" userDrawn="1">
          <p15:clr>
            <a:srgbClr val="A4A3A4"/>
          </p15:clr>
        </p15:guide>
        <p15:guide id="2" pos="27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1622" y="-1992"/>
      </p:cViewPr>
      <p:guideLst>
        <p:guide orient="horz" pos="3504"/>
        <p:guide pos="27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54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155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861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503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554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233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895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706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086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306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511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BEE0D-FE76-4782-AB3E-6E577AC0408A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9FA3F8-409D-4762-B5B1-61BE2E481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34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562610" y="1098220"/>
            <a:ext cx="5929630" cy="452431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8    VDAAPSPSPKPDPKPSPPPPSPKPAKERRFFAYSGIPKTKIKTKGNDDSIIASSNLEQQV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RYIEANNQKDVTLNARWYSTSTVKNKPMIVFDVPA  96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52   VDAAPSPSPKPDPKPSPPPPSPKPAKERRFFAYSGIPKTKIKTKGNDDSIIASSNLEQQV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RYIEANNQKDVTLNARWYSTSTVKNKPMIVFDVPA  96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85   VDAAPSPSPKPDPKPSPPPPSPKPAKERRFFAYSGIPKTKIKTKGNDDSIIASSNLEQQV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RYIEANYQKDVTLNARWYSTSTAKNKPMIVFDVPA  96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143  VDAAPSPSPKPDPRPGPPPPSPKPAKERRFFAYSGIPKTKIKTKGNDDSIIASSNLEQQV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RYIEANNQKDVTLNARWYSTSTVKNKPMIVFDVPA  96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</a:t>
            </a: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**:*.********************************************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 ***************.************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8    GDWFVDFLCEGYMPIEAIGGSEDQ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WMGIVAYNNDTADIWSVGVYDNVSITELNITSSWKLGHKDLELNGCHFHDGQVVERDSIGSCKVSSNTGGS  192</a:t>
            </a: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52   GDWFVDFLCEGYMPIEAIGGSEDQ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WMGIVAYNNDTADIWSVGVYDNVSITELNITSSWKLGHKDLELNGCHFHDGQVVERDSIGSCKVSSNTGGS  192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85   GDWFVDFLCEGYMPIEAIGGSEDQ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WMGIVAYNNDTADIWSVGVYDNVSITELNITSSWKLGHKDLELNGCHFHDGQVVERDSIGSCKVSSNTGGS  192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143  GDWFVDFLCEGYMPIEAIGGSEDQ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KWMGIVAYNNDTADIWSVGVYDNVSITELNITSSWKLGHKDLELNGCHFHDGQVVERDSIGSCKVSSNTGGS  192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*************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*************************************************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*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8    LFLVAPSIMKTAKYNYCVSYGDYTDKTLEFGFVSMVFDERDGANTAVP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IRRELKNVKYLRPSPVRLNDGGDYIDEVQKPIAAAPPSAKRPTSSRF  288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52   LFLVAPSIMKTEKYNYCVSYGDYTDKTLEFGFVSMVFDERDGANTAVP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IRRELKNVKYLRPSPVRLSDGGDYIDEVQKPIAAAPPSAKRPSSARH  288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85   LFLVAPSIMKTEKYNYCVSYGDYTDKTLEFGFVSMVFDERDGANTAVP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IRRELKNVKYLRPSPVRLSDGGDYIDEVQKPIAAAPLSAKRPPNARS  288 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143  LFLVAPSIMKTEKYNYCVSYGDYTDKTLEFGFVSMVFDERDGANTAVP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IRRELKNVKYLRPSPVRLSDGGDYIDEVQKPIAAAPLPAKRPPNARS  288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</a:t>
            </a: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 ************************************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********.*****************  **** .:* 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700" dirty="0">
              <a:solidFill>
                <a:srgbClr val="222222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8    VVAPEPKPEPAP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EPKPEPAPEPQPEVSQSPQREPAVPTKEPAVPTNEPFWPISVIDSIHVAEVTTSDESKIRVPLETRDPDGNILSLHPGGLNAMG  384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52   VVAPEPQPEPA-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PEPQPGVSQSPKRE-------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LPVNEPFWPISVIDSIHVAEVTTSDESKIRVPLETRDPDGNILSLHPGGLNAMG  369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85   MVAPEPKPVPA-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PEPQPEVSQSPTRE-------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VPTNEPFWPISVIDSIHVAEVTTSDESKIRVPLETRDPDGNILALHPGGLNAMG  369 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143  MVAPEPKPVPA-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PEPQPEVSQSPKRE-------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VPTNEPFWPISVIDSIHVAEVTTSDESKIRVPLETRDPDGNILALHPGGLNAMG  369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</a:t>
            </a: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:*****:* **        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 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 **       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:*.***************************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**:**********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700" dirty="0">
              <a:solidFill>
                <a:srgbClr val="222222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8    RDLQQFERDAVYKMWVEGQAEDIRRKQIETDAASAR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ISENDYRQINQEIRAAELPNQPNFVYRDDPIVKQNSTSDFIAARRADFDEQSVSDLKSN  480</a:t>
            </a:r>
            <a:endParaRPr lang="en-US" altLang="en-US" sz="700" dirty="0">
              <a:solidFill>
                <a:srgbClr val="222222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52   RDLQQFERDAVYKMWVEGQAEDIRRKQIETDAALAR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ISENDYRQINQEIRAAELPNQPNFVYRDDPIVKQNSTSDFIAARRADFDEQSASDLKSN  465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85   RDLQQFERDAVYKMWVEGQAEDIRRKQIETDAALAR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ISENDYRQINQEILATELPNQPNFVYRDDPIVKQNSTSDFIAARRADFDEQSISDLKSN  465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143  RDLQQFERDAVYKMWVEGQAEDIRRKQIETDAALAR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ISENDYRQINQEILATELPNQPNFVYRDDPIVKQNSTSDFIAARRADFDEQSISDLKSN  465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********************** **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*** *:************************************ 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8    ASTRTITGNLGGGKLKKKANDLDDVEDKILKALPEIDYKPSEILGVKARYHGGCGKWRDT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DSSMNCRCWMPTLEWQQVDFQYKGKASKNEGKSII  576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52   ASTRTITGNLGGGNLKKKASDLDVVEDRILKALPEIDYKPSEILGVKARYHGGCGKWRDT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DSSMNCRCWMPTLEWQQVDFQYKGKASRNEGKFMI  561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85   ASTRTITGNLGGGKLKKKASDLDVVEDRILKAVPGIDYKPSEILGVKARYHGGCGKWKDT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DSSMNCRCWMPTLEWQQVDFQYKGKASRNEGKSMI  561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143  ASTRTITGNLGGGKLKKKASDLDVVEDQILKAVPGIDYKPSEILGVKARYHGGCGKWKDT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DSSMNCRCWMPTLEWQQVDFQYKGKASRNEGKSMI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561         </a:t>
            </a: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**:*****.*** ***:****:* **********************:**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*****************:**** :*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8    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WPP  580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52   SWPP  565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85   SWPP  565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143  SWPP  565          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****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11480" y="238510"/>
            <a:ext cx="578865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 smtClean="0"/>
              <a:t>Figure S1.  Multiple sequence alignment of the deduced </a:t>
            </a:r>
            <a:r>
              <a:rPr lang="en-CA" sz="1000" b="1" dirty="0"/>
              <a:t>amino acid sequences </a:t>
            </a:r>
            <a:r>
              <a:rPr lang="en-CA" sz="1000" b="1" dirty="0" smtClean="0"/>
              <a:t>of ORF5, ORF5a and ORF8 from PA8 and BC isolates of ALV1</a:t>
            </a:r>
            <a:endParaRPr lang="en-US" sz="1000" dirty="0"/>
          </a:p>
        </p:txBody>
      </p:sp>
      <p:sp>
        <p:nvSpPr>
          <p:cNvPr id="11" name="Rectangle 2"/>
          <p:cNvSpPr>
            <a:spLocks noChangeArrowheads="1"/>
          </p:cNvSpPr>
          <p:nvPr/>
        </p:nvSpPr>
        <p:spPr bwMode="auto">
          <a:xfrm>
            <a:off x="562610" y="6152257"/>
            <a:ext cx="6003290" cy="646331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     MKFRNRLQRPPHLQSDPPVQDLWSHRNLNRNLLRNLNRNLLRNLNRKSHSLHSGNPLCRP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NPLCRPMSHSGQSQSLIAYMLRKSPHLMNPRYVYL 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96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52   MKFRNRLQRPPLLQSDPPVQDTWSHRNLNRNLP--------RNLNRESHSLPS-------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NPLCRLMSHSGQSQLLIAYMLRKSPHLMNPRYVYL  81</a:t>
            </a:r>
            <a:endParaRPr lang="en-US" altLang="en-US" sz="700" dirty="0">
              <a:solidFill>
                <a:srgbClr val="222222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85   MKFRNRLQRPPFLQSDLQMLDPWSHRNLNRYLL--------RNLNRKSHSLQR-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SPLCR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TSHSGQSQ---------------------  60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134  MKFRNRLQRPPFLQSDLQMLDPWSHRNLNRYLL--------RNLNRKSHSLQS-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</a:t>
            </a: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SPLCR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TSHSGQSQ---------------------  60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 ****  : * ******** *         *****:****           ****  *******   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0543" y="851999"/>
            <a:ext cx="17299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 smtClean="0"/>
              <a:t>ORF5 (readthrough domain)</a:t>
            </a:r>
            <a:endParaRPr lang="en-US" sz="1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70543" y="5890796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 smtClean="0"/>
              <a:t>ORF5a</a:t>
            </a:r>
            <a:endParaRPr lang="en-US" sz="1000" b="1" dirty="0"/>
          </a:p>
        </p:txBody>
      </p:sp>
      <p:sp>
        <p:nvSpPr>
          <p:cNvPr id="18" name="Rectangle 3"/>
          <p:cNvSpPr>
            <a:spLocks noChangeArrowheads="1"/>
          </p:cNvSpPr>
          <p:nvPr/>
        </p:nvSpPr>
        <p:spPr bwMode="auto">
          <a:xfrm>
            <a:off x="562610" y="7305088"/>
            <a:ext cx="5929630" cy="430887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52   MRREVGPRGAVTSLNNATVCELTQSGAKSTFGGLFGVAPPEMGRAEALRPRAVGHLRPDR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LSSIPPPTTTGPWFVTRS  79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85   -----------------------------------------MGRAEALRPRAVGHLRLDR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LSSIPPPTTTGPWFVTRS  38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	</a:t>
            </a: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BC134  -----------------------------------------MGRAEALRPRAVGHLRLDR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LSSIPPPTTTGPWFVTRS  38 </a:t>
            </a: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                                 **************** **</a:t>
            </a:r>
            <a:r>
              <a:rPr lang="en-US" altLang="en-US" sz="7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******************</a:t>
            </a: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70543" y="7043924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 smtClean="0"/>
              <a:t>ORF8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774342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6</TotalTime>
  <Words>208</Words>
  <Application>Microsoft Office PowerPoint</Application>
  <PresentationFormat>Letter Paper (8.5x11 in)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facon, Helene (AAFC/AAC)</dc:creator>
  <cp:lastModifiedBy>Sanfacon, Helene (AAFC/AAC)</cp:lastModifiedBy>
  <cp:revision>10</cp:revision>
  <dcterms:created xsi:type="dcterms:W3CDTF">2022-09-09T16:38:28Z</dcterms:created>
  <dcterms:modified xsi:type="dcterms:W3CDTF">2022-09-09T22:15:12Z</dcterms:modified>
</cp:coreProperties>
</file>